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65938" cy="99980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99FF"/>
    <a:srgbClr val="70AD47"/>
    <a:srgbClr val="5B9BD5"/>
    <a:srgbClr val="FF9900"/>
    <a:srgbClr val="ED7D31"/>
    <a:srgbClr val="9966FF"/>
    <a:srgbClr val="FF99FF"/>
    <a:srgbClr val="FF66FF"/>
    <a:srgbClr val="FFC000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52" autoAdjust="0"/>
    <p:restoredTop sz="94660"/>
  </p:normalViewPr>
  <p:slideViewPr>
    <p:cSldViewPr snapToGrid="0">
      <p:cViewPr varScale="1">
        <p:scale>
          <a:sx n="45" d="100"/>
          <a:sy n="45" d="100"/>
        </p:scale>
        <p:origin x="60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44260;&#52649;&#48516;&#51088;&#44228;&#53685;&#48516;&#47448;&#48143;&#50672;&#44396;&#49892;\Desktop\&#54364;&#51648;\2023&#45380;%20&#49892;&#54744;\&#44256;&#52628;&#51328;&#51104;&#51088;&#47532;\&#53804;&#44256;%20&#51204;%20&#54260;&#45908;\&#49892;&#54744;,%20&#48516;&#49437;%20&#47560;&#47924;&#47532;\2022-4(ITS%20region%20PCR)\&#52628;&#44032;%20data\pairwise%20tab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MT!$AO$14</c:f>
              <c:strCache>
                <c:ptCount val="1"/>
                <c:pt idx="0">
                  <c:v>CO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ko-KR"/>
                      <a:t>2.0%</a:t>
                    </a:r>
                  </a:p>
                  <a:p>
                    <a:r>
                      <a:rPr lang="en-US" altLang="ko-KR"/>
                      <a:t>(</a:t>
                    </a:r>
                    <a:fld id="{1AE99F9D-9E9C-44D5-9911-3232023C0CE0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CBD7-49A8-996F-14C7B890B318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 altLang="ko-KR"/>
                      <a:t>15.3%</a:t>
                    </a:r>
                  </a:p>
                  <a:p>
                    <a:r>
                      <a:rPr lang="en-US" altLang="ko-KR"/>
                      <a:t>(</a:t>
                    </a:r>
                    <a:fld id="{63AB909A-BBBA-42C7-9AEE-2ED5B0E44DF1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CBD7-49A8-996F-14C7B890B318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ko-KR"/>
                      <a:t>25.6%</a:t>
                    </a:r>
                  </a:p>
                  <a:p>
                    <a:r>
                      <a:rPr lang="en-US" altLang="ko-KR"/>
                      <a:t>(</a:t>
                    </a:r>
                    <a:fld id="{6D019BBF-ED83-4F78-B038-E22F3C59C845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CBD7-49A8-996F-14C7B890B318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 altLang="ko-KR"/>
                      <a:t>25.6%</a:t>
                    </a:r>
                  </a:p>
                  <a:p>
                    <a:r>
                      <a:rPr lang="en-US" altLang="ko-KR"/>
                      <a:t>(</a:t>
                    </a:r>
                    <a:fld id="{E57EF375-0C77-4222-80D6-1ECB5DE15FD6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CBD7-49A8-996F-14C7B890B318}"/>
                </c:ext>
              </c:extLst>
            </c:dLbl>
            <c:dLbl>
              <c:idx val="4"/>
              <c:layout>
                <c:manualLayout>
                  <c:x val="-8.4432348293396296E-17"/>
                  <c:y val="-6.2254901960785078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17.5%</a:t>
                    </a:r>
                  </a:p>
                  <a:p>
                    <a:r>
                      <a:rPr lang="en-US" altLang="ko-KR"/>
                      <a:t>(</a:t>
                    </a:r>
                    <a:fld id="{2C90C165-13DC-4ED5-8CBE-59C68A4035B7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CBD7-49A8-996F-14C7B890B318}"/>
                </c:ext>
              </c:extLst>
            </c:dLbl>
            <c:dLbl>
              <c:idx val="5"/>
              <c:layout>
                <c:manualLayout>
                  <c:x val="1.1513635044966637E-3"/>
                  <c:y val="-7.6088445638519489E-17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9.7%</a:t>
                    </a:r>
                  </a:p>
                  <a:p>
                    <a:r>
                      <a:rPr lang="en-US" altLang="ko-KR"/>
                      <a:t>(</a:t>
                    </a:r>
                    <a:fld id="{8D25A6A4-BCC6-43C8-B53B-56C6CA9CFCBF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C-CBD7-49A8-996F-14C7B890B318}"/>
                </c:ext>
              </c:extLst>
            </c:dLbl>
            <c:dLbl>
              <c:idx val="6"/>
              <c:layout>
                <c:manualLayout>
                  <c:x val="-8.4432348293396296E-17"/>
                  <c:y val="-2.0751633986928106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3.3%</a:t>
                    </a:r>
                  </a:p>
                  <a:p>
                    <a:r>
                      <a:rPr lang="en-US" altLang="ko-KR"/>
                      <a:t>(</a:t>
                    </a:r>
                    <a:fld id="{B660A10E-FA99-48AB-B8A4-F46D4CC6CD3F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CBD7-49A8-996F-14C7B890B318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 altLang="ko-KR"/>
                      <a:t>0.9%</a:t>
                    </a:r>
                  </a:p>
                  <a:p>
                    <a:r>
                      <a:rPr lang="en-US" altLang="ko-KR"/>
                      <a:t>(</a:t>
                    </a:r>
                    <a:fld id="{23511084-A7DC-4593-BA34-B5A19B58CA52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E-CBD7-49A8-996F-14C7B890B31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 altLang="ko-KR"/>
                      <a:t>0.2%</a:t>
                    </a:r>
                  </a:p>
                  <a:p>
                    <a:r>
                      <a:rPr lang="en-US" altLang="ko-KR"/>
                      <a:t>(</a:t>
                    </a:r>
                    <a:fld id="{E0A0FDC4-9C63-4E2C-9145-FF55EF29EA06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CBD7-49A8-996F-14C7B890B31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rgbClr val="4472C4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numRef>
              <c:f>SMT!$AP$13:$BA$13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SMT!$AP$14:$BA$14</c:f>
              <c:numCache>
                <c:formatCode>General</c:formatCode>
                <c:ptCount val="12"/>
                <c:pt idx="0">
                  <c:v>41</c:v>
                </c:pt>
                <c:pt idx="1">
                  <c:v>318</c:v>
                </c:pt>
                <c:pt idx="2">
                  <c:v>533</c:v>
                </c:pt>
                <c:pt idx="3">
                  <c:v>532</c:v>
                </c:pt>
                <c:pt idx="4">
                  <c:v>363</c:v>
                </c:pt>
                <c:pt idx="5">
                  <c:v>201</c:v>
                </c:pt>
                <c:pt idx="6">
                  <c:v>69</c:v>
                </c:pt>
                <c:pt idx="7">
                  <c:v>19</c:v>
                </c:pt>
                <c:pt idx="8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D7-49A8-996F-14C7B890B318}"/>
            </c:ext>
          </c:extLst>
        </c:ser>
        <c:ser>
          <c:idx val="1"/>
          <c:order val="1"/>
          <c:tx>
            <c:strRef>
              <c:f>SMT!$AO$15</c:f>
              <c:strCache>
                <c:ptCount val="1"/>
                <c:pt idx="0">
                  <c:v>16S rRN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ko-KR"/>
                      <a:t>10.0%</a:t>
                    </a:r>
                  </a:p>
                  <a:p>
                    <a:r>
                      <a:rPr lang="en-US" altLang="ko-KR"/>
                      <a:t>(</a:t>
                    </a:r>
                    <a:fld id="{E69949FA-73D7-471E-A63B-26673EA51B5B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CBD7-49A8-996F-14C7B890B318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 altLang="ko-KR"/>
                      <a:t>64.7%</a:t>
                    </a:r>
                  </a:p>
                  <a:p>
                    <a:r>
                      <a:rPr lang="en-US" altLang="ko-KR"/>
                      <a:t>(</a:t>
                    </a:r>
                    <a:fld id="{AE8A09FB-08BC-431D-A559-C5D411806A83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0-CBD7-49A8-996F-14C7B890B318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ko-KR"/>
                      <a:t>23.7%</a:t>
                    </a:r>
                  </a:p>
                  <a:p>
                    <a:r>
                      <a:rPr lang="en-US" altLang="ko-KR"/>
                      <a:t>(</a:t>
                    </a:r>
                    <a:fld id="{C46CC5B2-8A3E-427C-8FA7-982FC9A7EB3A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CBD7-49A8-996F-14C7B890B318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 altLang="ko-KR"/>
                      <a:t>1.6%</a:t>
                    </a:r>
                  </a:p>
                  <a:p>
                    <a:r>
                      <a:rPr lang="en-US" altLang="ko-KR"/>
                      <a:t>(</a:t>
                    </a:r>
                    <a:fld id="{539919BF-278D-4BD2-90AC-2F7BA842D57A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2-CBD7-49A8-996F-14C7B890B31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rgbClr val="ED7D3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SMT!$AP$13:$BA$13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SMT!$AP$15:$BA$15</c:f>
              <c:numCache>
                <c:formatCode>General</c:formatCode>
                <c:ptCount val="12"/>
                <c:pt idx="0">
                  <c:v>19</c:v>
                </c:pt>
                <c:pt idx="1">
                  <c:v>123</c:v>
                </c:pt>
                <c:pt idx="2">
                  <c:v>45</c:v>
                </c:pt>
                <c:pt idx="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D7-49A8-996F-14C7B890B318}"/>
            </c:ext>
          </c:extLst>
        </c:ser>
        <c:ser>
          <c:idx val="2"/>
          <c:order val="2"/>
          <c:tx>
            <c:strRef>
              <c:f>SMT!$AO$16</c:f>
              <c:strCache>
                <c:ptCount val="1"/>
                <c:pt idx="0">
                  <c:v>COI + 16S rRN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rgbClr val="A5A5A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CBD7-49A8-996F-14C7B890B318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ko-KR" dirty="0"/>
                      <a:t>1.3%</a:t>
                    </a:r>
                  </a:p>
                  <a:p>
                    <a:r>
                      <a:rPr lang="en-US" altLang="ko-KR" dirty="0"/>
                      <a:t>(</a:t>
                    </a:r>
                    <a:fld id="{1EAA7129-55AE-4CB6-94F1-E851E3A76DF5}" type="VALUE">
                      <a:rPr lang="en-US" altLang="ko-KR" smtClean="0"/>
                      <a:pPr/>
                      <a:t>[값]</a:t>
                    </a:fld>
                    <a:r>
                      <a:rPr lang="en-US" altLang="ko-KR" dirty="0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CBD7-49A8-996F-14C7B890B318}"/>
                </c:ext>
              </c:extLst>
            </c:dLbl>
            <c:dLbl>
              <c:idx val="1"/>
              <c:layout>
                <c:manualLayout>
                  <c:x val="-1.151363504496685E-3"/>
                  <c:y val="-7.6088445638519489E-17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8.9%</a:t>
                    </a:r>
                  </a:p>
                  <a:p>
                    <a:r>
                      <a:rPr lang="en-US" altLang="ko-KR"/>
                      <a:t>(</a:t>
                    </a:r>
                    <a:fld id="{12E7A20D-0E1B-4E22-96E8-F27DE2C970AE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CBD7-49A8-996F-14C7B890B318}"/>
                </c:ext>
              </c:extLst>
            </c:dLbl>
            <c:dLbl>
              <c:idx val="2"/>
              <c:layout>
                <c:manualLayout>
                  <c:x val="-4.2216174146698148E-17"/>
                  <c:y val="-6.2254901960784315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17.7%</a:t>
                    </a:r>
                  </a:p>
                  <a:p>
                    <a:r>
                      <a:rPr lang="en-US" altLang="ko-KR"/>
                      <a:t>(</a:t>
                    </a:r>
                    <a:fld id="{0995BE2D-9728-4827-95D5-6BCE9EDB4FC6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4-CBD7-49A8-996F-14C7B890B318}"/>
                </c:ext>
              </c:extLst>
            </c:dLbl>
            <c:dLbl>
              <c:idx val="3"/>
              <c:layout>
                <c:manualLayout>
                  <c:x val="-4.2216174146698148E-17"/>
                  <c:y val="4.1503267973855831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 dirty="0"/>
                      <a:t>25.7%</a:t>
                    </a:r>
                  </a:p>
                  <a:p>
                    <a:r>
                      <a:rPr lang="en-US" altLang="ko-KR" dirty="0"/>
                      <a:t>(</a:t>
                    </a:r>
                    <a:fld id="{F8C72BDE-DAE7-4D6F-9CEB-4C2CAC4A03BD}" type="VALUE">
                      <a:rPr lang="en-US" altLang="ko-KR" smtClean="0"/>
                      <a:pPr/>
                      <a:t>[값]</a:t>
                    </a:fld>
                    <a:r>
                      <a:rPr lang="en-US" altLang="ko-KR" dirty="0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CBD7-49A8-996F-14C7B890B318}"/>
                </c:ext>
              </c:extLst>
            </c:dLbl>
            <c:dLbl>
              <c:idx val="4"/>
              <c:layout>
                <c:manualLayout>
                  <c:x val="0"/>
                  <c:y val="-2.0751633986928106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21.7%</a:t>
                    </a:r>
                  </a:p>
                  <a:p>
                    <a:r>
                      <a:rPr lang="en-US" altLang="ko-KR"/>
                      <a:t>(</a:t>
                    </a:r>
                    <a:fld id="{365E6AD8-7856-482E-A2CC-58E2C220C901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6-CBD7-49A8-996F-14C7B890B31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 altLang="ko-KR"/>
                      <a:t>16.0%</a:t>
                    </a:r>
                  </a:p>
                  <a:p>
                    <a:r>
                      <a:rPr lang="en-US" altLang="ko-KR"/>
                      <a:t>(</a:t>
                    </a:r>
                    <a:fld id="{6DF361D9-05A5-40B2-A6B6-D64AB147D84A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7-CBD7-49A8-996F-14C7B890B318}"/>
                </c:ext>
              </c:extLst>
            </c:dLbl>
            <c:dLbl>
              <c:idx val="6"/>
              <c:layout>
                <c:manualLayout>
                  <c:x val="-8.4432348293396296E-17"/>
                  <c:y val="-1.2450980392156939E-2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6.1%</a:t>
                    </a:r>
                  </a:p>
                  <a:p>
                    <a:r>
                      <a:rPr lang="en-US" altLang="ko-KR"/>
                      <a:t>(</a:t>
                    </a:r>
                    <a:fld id="{92D424AB-CA57-4F5A-83F8-E9E29533BF35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8-CBD7-49A8-996F-14C7B890B318}"/>
                </c:ext>
              </c:extLst>
            </c:dLbl>
            <c:dLbl>
              <c:idx val="7"/>
              <c:layout>
                <c:manualLayout>
                  <c:x val="0"/>
                  <c:y val="6.2254901960784315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2.2%</a:t>
                    </a:r>
                  </a:p>
                  <a:p>
                    <a:r>
                      <a:rPr lang="en-US" altLang="ko-KR"/>
                      <a:t>(</a:t>
                    </a:r>
                    <a:fld id="{0EEA609C-0B0C-428A-9B87-CB09EA376FA9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9-CBD7-49A8-996F-14C7B890B31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 altLang="ko-KR"/>
                      <a:t>0.4%</a:t>
                    </a:r>
                  </a:p>
                  <a:p>
                    <a:r>
                      <a:rPr lang="en-US" altLang="ko-KR"/>
                      <a:t>(</a:t>
                    </a:r>
                    <a:fld id="{8AEBA536-EF68-4CD4-BA4D-CE1A1240D0D2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A-CBD7-49A8-996F-14C7B890B31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 altLang="ko-KR"/>
                      <a:t>0.1%</a:t>
                    </a:r>
                  </a:p>
                  <a:p>
                    <a:r>
                      <a:rPr lang="en-US" altLang="ko-KR"/>
                      <a:t>(</a:t>
                    </a:r>
                    <a:fld id="{E090AE05-3E7F-4053-9101-4E7E5287DF00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B-CBD7-49A8-996F-14C7B890B31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rgbClr val="A5A5A5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numRef>
              <c:f>SMT!$AP$13:$BA$13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SMT!$AP$16:$BA$16</c:f>
              <c:numCache>
                <c:formatCode>General</c:formatCode>
                <c:ptCount val="12"/>
                <c:pt idx="0">
                  <c:v>35</c:v>
                </c:pt>
                <c:pt idx="1">
                  <c:v>233</c:v>
                </c:pt>
                <c:pt idx="2">
                  <c:v>465</c:v>
                </c:pt>
                <c:pt idx="3">
                  <c:v>675</c:v>
                </c:pt>
                <c:pt idx="4">
                  <c:v>569</c:v>
                </c:pt>
                <c:pt idx="5">
                  <c:v>420</c:v>
                </c:pt>
                <c:pt idx="6">
                  <c:v>160</c:v>
                </c:pt>
                <c:pt idx="7">
                  <c:v>59</c:v>
                </c:pt>
                <c:pt idx="8">
                  <c:v>10</c:v>
                </c:pt>
                <c:pt idx="9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BD7-49A8-996F-14C7B890B318}"/>
            </c:ext>
          </c:extLst>
        </c:ser>
        <c:ser>
          <c:idx val="3"/>
          <c:order val="3"/>
          <c:tx>
            <c:strRef>
              <c:f>SMT!$AO$17</c:f>
              <c:strCache>
                <c:ptCount val="1"/>
                <c:pt idx="0">
                  <c:v>ITS regio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ko-KR" dirty="0"/>
                      <a:t>2.2%</a:t>
                    </a:r>
                  </a:p>
                  <a:p>
                    <a:r>
                      <a:rPr lang="en-US" altLang="ko-KR" dirty="0"/>
                      <a:t>(</a:t>
                    </a:r>
                    <a:fld id="{37375076-D690-49DC-846B-A003F4E470FB}" type="VALUE">
                      <a:rPr lang="en-US" altLang="ko-KR" smtClean="0"/>
                      <a:pPr/>
                      <a:t>[값]</a:t>
                    </a:fld>
                    <a:r>
                      <a:rPr lang="en-US" altLang="ko-KR" dirty="0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CBD7-49A8-996F-14C7B890B318}"/>
                </c:ext>
              </c:extLst>
            </c:dLbl>
            <c:dLbl>
              <c:idx val="1"/>
              <c:layout>
                <c:manualLayout>
                  <c:x val="-1.1513635044966637E-3"/>
                  <c:y val="-7.6088445638519489E-17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14.4%</a:t>
                    </a:r>
                  </a:p>
                  <a:p>
                    <a:r>
                      <a:rPr lang="en-US" altLang="ko-KR"/>
                      <a:t>(</a:t>
                    </a:r>
                    <a:fld id="{8FB804EB-7B90-45B0-9AC4-3296655936B5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C-CBD7-49A8-996F-14C7B890B318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ko-KR"/>
                      <a:t>14.5%</a:t>
                    </a:r>
                  </a:p>
                  <a:p>
                    <a:r>
                      <a:rPr lang="en-US" altLang="ko-KR"/>
                      <a:t>(</a:t>
                    </a:r>
                    <a:fld id="{552F0046-5941-458D-BD46-C475CE3DECF0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D-CBD7-49A8-996F-14C7B890B318}"/>
                </c:ext>
              </c:extLst>
            </c:dLbl>
            <c:dLbl>
              <c:idx val="3"/>
              <c:layout>
                <c:manualLayout>
                  <c:x val="1.1513635044966637E-3"/>
                  <c:y val="-2.0751633986928865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 sz="700" dirty="0"/>
                      <a:t>21.9%</a:t>
                    </a:r>
                  </a:p>
                  <a:p>
                    <a:r>
                      <a:rPr lang="en-US" altLang="ko-KR" sz="700" dirty="0"/>
                      <a:t>(</a:t>
                    </a:r>
                    <a:fld id="{54E83F5A-D6CC-4F61-9E75-3C921D35F417}" type="VALUE">
                      <a:rPr lang="en-US" altLang="ko-KR" sz="700" smtClean="0"/>
                      <a:pPr/>
                      <a:t>[값]</a:t>
                    </a:fld>
                    <a:r>
                      <a:rPr lang="en-US" altLang="ko-KR" sz="700" dirty="0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E-CBD7-49A8-996F-14C7B890B318}"/>
                </c:ext>
              </c:extLst>
            </c:dLbl>
            <c:dLbl>
              <c:idx val="4"/>
              <c:layout>
                <c:manualLayout>
                  <c:x val="2.3027270089933274E-3"/>
                  <c:y val="2.0751633986927343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 dirty="0"/>
                      <a:t>21.3%</a:t>
                    </a:r>
                  </a:p>
                  <a:p>
                    <a:r>
                      <a:rPr lang="en-US" altLang="ko-KR" dirty="0"/>
                      <a:t>(</a:t>
                    </a:r>
                    <a:fld id="{8BE355F6-C3F1-4FEF-9584-ABCEACE6A9D5}" type="VALUE">
                      <a:rPr lang="en-US" altLang="ko-KR" smtClean="0"/>
                      <a:pPr/>
                      <a:t>[값]</a:t>
                    </a:fld>
                    <a:r>
                      <a:rPr lang="en-US" altLang="ko-KR" dirty="0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F-CBD7-49A8-996F-14C7B890B318}"/>
                </c:ext>
              </c:extLst>
            </c:dLbl>
            <c:dLbl>
              <c:idx val="5"/>
              <c:layout>
                <c:manualLayout>
                  <c:x val="2.3027270089932433E-3"/>
                  <c:y val="-8.3006535947712425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10.6%</a:t>
                    </a:r>
                  </a:p>
                  <a:p>
                    <a:r>
                      <a:rPr lang="en-US" altLang="ko-KR"/>
                      <a:t>(</a:t>
                    </a:r>
                    <a:fld id="{578738BE-F7F7-4397-97C8-B4DD132577A6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0-CBD7-49A8-996F-14C7B890B318}"/>
                </c:ext>
              </c:extLst>
            </c:dLbl>
            <c:dLbl>
              <c:idx val="6"/>
              <c:layout>
                <c:manualLayout>
                  <c:x val="1.1513635044966637E-3"/>
                  <c:y val="1.5217689127703898E-16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8.6%</a:t>
                    </a:r>
                  </a:p>
                  <a:p>
                    <a:r>
                      <a:rPr lang="en-US" altLang="ko-KR"/>
                      <a:t>(</a:t>
                    </a:r>
                    <a:fld id="{797CDA86-8349-42FB-89AA-614A49857330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1-CBD7-49A8-996F-14C7B890B318}"/>
                </c:ext>
              </c:extLst>
            </c:dLbl>
            <c:dLbl>
              <c:idx val="7"/>
              <c:layout>
                <c:manualLayout>
                  <c:x val="0"/>
                  <c:y val="2.0751633986928106E-3"/>
                </c:manualLayout>
              </c:layout>
              <c:tx>
                <c:rich>
                  <a:bodyPr/>
                  <a:lstStyle/>
                  <a:p>
                    <a:r>
                      <a:rPr lang="en-US" altLang="ko-KR"/>
                      <a:t>3.5%</a:t>
                    </a:r>
                  </a:p>
                  <a:p>
                    <a:r>
                      <a:rPr lang="en-US" altLang="ko-KR"/>
                      <a:t>(</a:t>
                    </a:r>
                    <a:fld id="{D5D1338C-F073-4B84-8494-B965AF470CDC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2-CBD7-49A8-996F-14C7B890B31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 altLang="ko-KR"/>
                      <a:t>1.8%</a:t>
                    </a:r>
                  </a:p>
                  <a:p>
                    <a:r>
                      <a:rPr lang="en-US" altLang="ko-KR"/>
                      <a:t>(</a:t>
                    </a:r>
                    <a:fld id="{203CBD9D-0B00-4489-A96C-64295A99AF10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3-CBD7-49A8-996F-14C7B890B31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 altLang="ko-KR"/>
                      <a:t>0.8%</a:t>
                    </a:r>
                  </a:p>
                  <a:p>
                    <a:r>
                      <a:rPr lang="en-US" altLang="ko-KR"/>
                      <a:t>(</a:t>
                    </a:r>
                    <a:fld id="{1548E72F-DBB9-425E-BCDC-A8569C8D16B3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4-CBD7-49A8-996F-14C7B890B318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 altLang="ko-KR"/>
                      <a:t>0.1%</a:t>
                    </a:r>
                  </a:p>
                  <a:p>
                    <a:r>
                      <a:rPr lang="en-US" altLang="ko-KR"/>
                      <a:t>(</a:t>
                    </a:r>
                    <a:fld id="{008840CC-7C6F-4374-865B-22A3A6AD22CE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5-CBD7-49A8-996F-14C7B890B318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 altLang="ko-KR"/>
                      <a:t>0.1</a:t>
                    </a:r>
                  </a:p>
                  <a:p>
                    <a:r>
                      <a:rPr lang="en-US" altLang="ko-KR"/>
                      <a:t>(</a:t>
                    </a:r>
                    <a:fld id="{3A6BD260-1BF1-4FC3-94FC-62721A6E203E}" type="VALUE">
                      <a:rPr lang="en-US" altLang="ko-KR" smtClean="0"/>
                      <a:pPr/>
                      <a:t>[값]</a:t>
                    </a:fld>
                    <a:r>
                      <a:rPr lang="en-US" altLang="ko-KR"/>
                      <a:t>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6-CBD7-49A8-996F-14C7B890B31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rgbClr val="FFC000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numRef>
              <c:f>SMT!$AP$13:$BA$13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</c:numCache>
            </c:numRef>
          </c:cat>
          <c:val>
            <c:numRef>
              <c:f>SMT!$AP$17:$BA$17</c:f>
              <c:numCache>
                <c:formatCode>General</c:formatCode>
                <c:ptCount val="12"/>
                <c:pt idx="0">
                  <c:v>34</c:v>
                </c:pt>
                <c:pt idx="1">
                  <c:v>221</c:v>
                </c:pt>
                <c:pt idx="2">
                  <c:v>223</c:v>
                </c:pt>
                <c:pt idx="3">
                  <c:v>335</c:v>
                </c:pt>
                <c:pt idx="4">
                  <c:v>327</c:v>
                </c:pt>
                <c:pt idx="5">
                  <c:v>163</c:v>
                </c:pt>
                <c:pt idx="6">
                  <c:v>132</c:v>
                </c:pt>
                <c:pt idx="7">
                  <c:v>54</c:v>
                </c:pt>
                <c:pt idx="8">
                  <c:v>28</c:v>
                </c:pt>
                <c:pt idx="9">
                  <c:v>13</c:v>
                </c:pt>
                <c:pt idx="10">
                  <c:v>2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BD7-49A8-996F-14C7B890B318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0"/>
        <c:axId val="873473791"/>
        <c:axId val="1018527967"/>
      </c:barChart>
      <c:catAx>
        <c:axId val="8734737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1300"/>
                  <a:t>Base pair difference</a:t>
                </a:r>
                <a:endParaRPr lang="ko-KR" sz="13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1018527967"/>
        <c:crosses val="autoZero"/>
        <c:auto val="1"/>
        <c:lblAlgn val="ctr"/>
        <c:lblOffset val="100"/>
        <c:noMultiLvlLbl val="0"/>
      </c:catAx>
      <c:valAx>
        <c:axId val="10185279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/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1300"/>
                  <a:t>Number of pairs</a:t>
                </a:r>
                <a:endParaRPr lang="ko-KR" sz="13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/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873473791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</c:legendEntry>
      <c:layout>
        <c:manualLayout>
          <c:xMode val="edge"/>
          <c:yMode val="edge"/>
          <c:x val="0.33506980707861905"/>
          <c:y val="6.6591993464052299E-2"/>
          <c:w val="0.32876867565999418"/>
          <c:h val="4.25482026143790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Calibri" panose="020F0502020204030204" pitchFamily="34" charset="0"/>
          <a:cs typeface="Calibri" panose="020F050202020403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0E907B3-A368-438A-A510-81F50A7DE6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5FBF60B-4AD0-44BF-9732-3B46FCF50F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57A2425-D6A3-40D2-A7E6-A0DD9A377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CD0EFC6-5F53-473B-A8B7-760EEC718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A708F64-A823-4F86-BF84-3C515AA0F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554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8782FF-2E6B-4868-B645-1AE9928D8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C270EFF-9CAE-4464-BDB4-FAA49C0C70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C15C0B8-6735-4D25-916D-90471FB51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B352978-A745-4836-A1BB-FAEA4E7E4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54513F4-959C-433E-9FD9-5DEB347F0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660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B236847-3032-49F3-815B-29A9110406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BEC54BF-F9F2-4FAB-BA38-B5509A4F51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9A59814-BD33-4070-A521-25555DA9C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67F1CE5-2B53-483C-989F-FC8891E6C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6B18A8-0AE9-41E7-9B7D-537A01725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1848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3FCEFDF-9A35-41B3-ABF8-4204F470E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F7F5A65-AF09-4E80-A232-A0CC3CB446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7E865D-528E-425D-9617-4F43F7A13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8CA0269-7142-4A74-B359-8E433DB4A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64C05DA-CCB9-45BA-9164-F805EC60B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260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DEBC96-14AB-43FF-A9A3-04CF91E35A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C7B38E0-E558-448D-A9A1-C71A0772C4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3671C81-E840-4366-9555-3CBF423B0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14ABDD-0440-456B-8412-AD3697F3E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AD68E82-01D4-475A-8EF2-6CCFFBAE0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8939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C574685-6EF7-4E05-99AD-E2868E49D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C33910F-71D4-46B9-9091-37719C406E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B1F9687-CAEA-471E-B240-F03B9EAD01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D75673D-7F6A-48F2-8D7E-E94A70C0A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465890A-C4F7-4A78-B855-5C7B4718F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391BC7D-1929-4BDF-ACFE-92A4B817D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54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4B3A9FA-647C-4622-8FCF-AFD6B2326D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526A5FA-2FC0-4EC4-B516-29FD00DE77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BF782A2-18F4-41AB-871F-279F3EEC0A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7488AF3-8C52-4EBA-B66A-DDF8B3C55F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A35F1DC-DE1F-4A5D-B18B-88C0C29DB8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73001652-4EAC-4BDA-8ED5-C52A06B24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DB928D5-7438-4BDE-9E66-B5F8FEDDE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880F26F-4B80-40AD-B9FE-B8CED6C0E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9929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BC13B9B-DA3B-4920-A3CA-14C6B935B6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364ACA0-D0F1-4AFD-A5F4-81FC5F285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CF9DBB1-075B-4484-925C-C9D1DD826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9575FF72-143A-4C72-B887-0F193CD6D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276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5966FF2-F346-43D5-9F85-839BE4537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8408779-D244-480B-A869-8AA986DEE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290FF00-DBEC-489E-ABF8-4AA86CDDC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2953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B4A4A40-7B89-4C24-869C-70BEFF4382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7DA3CD5-782A-422D-8C8D-9F2FF65A37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CB0DBAC-0580-45FA-A92F-5ED9BB5249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27ED535-17D8-4937-8957-BD3A45EC7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C0D079B-796D-4EB5-BDC8-6599D704A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A954672-2626-4D9D-A9FD-3A83D8BF7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112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59FC324-2793-4A3A-932F-02EB61C8AC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9412688-2ABF-409B-9830-D0020A7C32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A3F4805-8189-41F9-922F-F346D69293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608C61B-F313-4127-9D34-C7F76FC7A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FB8B2AC-20D7-464F-B399-30E1372A7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16BCD59-C4E2-4031-9E6E-D958565DD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4246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5359CC9-FC5C-4821-ADA2-CBD4F4CCB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DDF1BD9-1443-4AFA-BAB7-CA63F5F936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2EAACBE-7A09-40A2-9B69-8641D83888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20C0B-DFB9-4BE0-A8D7-07B91882D11C}" type="datetimeFigureOut">
              <a:rPr lang="ko-KR" altLang="en-US" smtClean="0"/>
              <a:t>2023-08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43FC165-7722-408C-B006-E09ACFE954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557189C-9FBA-44DD-806C-DD8BF11EA7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976EC-14FD-4083-B71D-06D126D148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544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>
            <a:extLst>
              <a:ext uri="{FF2B5EF4-FFF2-40B4-BE49-F238E27FC236}">
                <a16:creationId xmlns:a16="http://schemas.microsoft.com/office/drawing/2014/main" id="{ED8B6B8A-0DCF-4F40-AB98-28ED97096E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9397120"/>
              </p:ext>
            </p:extLst>
          </p:nvPr>
        </p:nvGraphicFramePr>
        <p:xfrm>
          <a:off x="580800" y="26100"/>
          <a:ext cx="11030400" cy="61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직사각형 4">
            <a:extLst>
              <a:ext uri="{FF2B5EF4-FFF2-40B4-BE49-F238E27FC236}">
                <a16:creationId xmlns:a16="http://schemas.microsoft.com/office/drawing/2014/main" id="{075DA8AF-591A-42A1-94E4-497A5EA6E702}"/>
              </a:ext>
            </a:extLst>
          </p:cNvPr>
          <p:cNvSpPr/>
          <p:nvPr/>
        </p:nvSpPr>
        <p:spPr>
          <a:xfrm>
            <a:off x="662657" y="6146100"/>
            <a:ext cx="1086668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400" b="1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US" altLang="ko-KR" sz="1400" kern="100" dirty="0">
                <a:latin typeface="Calibri" panose="020F0502020204030204" pitchFamily="34" charset="0"/>
                <a:cs typeface="Times New Roman" panose="02020603050405020304" pitchFamily="18" charset="0"/>
              </a:rPr>
              <a:t>Distribution of pairwise distances in base pairs. The numbers within parentheses indicate actual differences between pairs of haplotypes.</a:t>
            </a:r>
            <a:endParaRPr lang="ko-KR" altLang="ko-KR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0804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203</Words>
  <Application>Microsoft Office PowerPoint</Application>
  <PresentationFormat>와이드스크린</PresentationFormat>
  <Paragraphs>7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표지영</dc:creator>
  <cp:lastModifiedBy>표지영</cp:lastModifiedBy>
  <cp:revision>22</cp:revision>
  <cp:lastPrinted>2023-08-13T08:46:25Z</cp:lastPrinted>
  <dcterms:created xsi:type="dcterms:W3CDTF">2023-03-10T12:23:12Z</dcterms:created>
  <dcterms:modified xsi:type="dcterms:W3CDTF">2023-08-21T11:47:34Z</dcterms:modified>
</cp:coreProperties>
</file>